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2" d="100"/>
          <a:sy n="92" d="100"/>
        </p:scale>
        <p:origin x="69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42542D-7C69-4C1B-AD4B-2781E1362EDB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921AD9-7B80-4ADA-B320-1DA05726B9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08549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Fig</a:t>
            </a:r>
            <a:r>
              <a:rPr lang="en-GB" baseline="0" dirty="0"/>
              <a:t> S1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6DB3FFA-3AD9-4FEB-8A03-5A612FF74AD4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22978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09134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51324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57840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7882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13780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2961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85473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4082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4974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40016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2428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68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Fig. S1</a:t>
            </a:r>
            <a:endParaRPr lang="en-GB" dirty="0"/>
          </a:p>
        </p:txBody>
      </p:sp>
      <p:pic>
        <p:nvPicPr>
          <p:cNvPr id="4" name="Picture 3"/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93" t="6473" r="4308" b="6328"/>
          <a:stretch/>
        </p:blipFill>
        <p:spPr bwMode="auto">
          <a:xfrm>
            <a:off x="0" y="2419346"/>
            <a:ext cx="5793135" cy="3618173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47" t="6273" r="4490" b="6545"/>
          <a:stretch/>
        </p:blipFill>
        <p:spPr bwMode="auto">
          <a:xfrm>
            <a:off x="6096000" y="2251027"/>
            <a:ext cx="5662857" cy="3786496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3" name="Rectangle 2"/>
          <p:cNvSpPr/>
          <p:nvPr/>
        </p:nvSpPr>
        <p:spPr>
          <a:xfrm>
            <a:off x="1103168" y="6257769"/>
            <a:ext cx="9985664" cy="3400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1400" i="1" dirty="0">
                <a:latin typeface="Gentium Basic" panose="02000503060000020004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Fig. S1. Profile of the head groups of fresh milk collected in positive mode of Direct Infusion-MS.   Panel A, all head groups; B, most abundant types.</a:t>
            </a:r>
            <a:endParaRPr lang="en-GB" sz="1400" dirty="0">
              <a:effectLst/>
              <a:latin typeface="Gentium Basic" panose="02000503060000020004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20312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39</Words>
  <Application>Microsoft Office PowerPoint</Application>
  <PresentationFormat>Widescreen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Gentium Basic</vt:lpstr>
      <vt:lpstr>Times New Roman</vt:lpstr>
      <vt:lpstr>Office Theme</vt:lpstr>
      <vt:lpstr>Fig. S1</vt:lpstr>
    </vt:vector>
  </TitlesOfParts>
  <Company>Clinical School Computing Servic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 1</dc:title>
  <dc:creator>Samuel Furse</dc:creator>
  <cp:lastModifiedBy>Samuel Furse</cp:lastModifiedBy>
  <cp:revision>7</cp:revision>
  <dcterms:created xsi:type="dcterms:W3CDTF">2019-04-10T14:00:46Z</dcterms:created>
  <dcterms:modified xsi:type="dcterms:W3CDTF">2019-04-29T07:42:13Z</dcterms:modified>
</cp:coreProperties>
</file>